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f" ContentType="image/tiff"/>
  <Default Extension="emf" ContentType="image/x-emf"/>
  <Default Extension="rels" ContentType="application/vnd.openxmlformats-package.relationships+xml"/>
  <Default Extension="tif" ContentType="image/tiff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58" r:id="rId3"/>
    <p:sldId id="271" r:id="rId4"/>
    <p:sldId id="269" r:id="rId5"/>
    <p:sldId id="270" r:id="rId6"/>
  </p:sldIdLst>
  <p:sldSz cx="9144000" cy="6858000" type="screen4x3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lena Rosini" initials="ER" lastIdx="2" clrIdx="0">
    <p:extLst>
      <p:ext uri="{19B8F6BF-5375-455C-9EA6-DF929625EA0E}">
        <p15:presenceInfo xmlns="" xmlns:p15="http://schemas.microsoft.com/office/powerpoint/2012/main" userId="7c68c0ed64e0133e" providerId="Windows Live"/>
      </p:ext>
    </p:extLst>
  </p:cmAuthor>
  <p:cmAuthor id="2" name="Elena Rosini" initials="ER [2]" lastIdx="2" clrIdx="1">
    <p:extLst>
      <p:ext uri="{19B8F6BF-5375-455C-9EA6-DF929625EA0E}">
        <p15:presenceInfo xmlns="" xmlns:p15="http://schemas.microsoft.com/office/powerpoint/2012/main" userId="570feb4bd1399a48" providerId="Windows Live"/>
      </p:ext>
    </p:extLst>
  </p:cmAuthor>
  <p:cmAuthor id="3" name="marta boreggio" initials="mb" lastIdx="1" clrIdx="2">
    <p:extLst>
      <p:ext uri="{19B8F6BF-5375-455C-9EA6-DF929625EA0E}">
        <p15:presenceInfo xmlns="" xmlns:p15="http://schemas.microsoft.com/office/powerpoint/2012/main" userId="4d8fe895e516b182" providerId="Windows Live"/>
      </p:ext>
    </p:extLst>
  </p:cmAuthor>
  <p:cmAuthor id="4" name="Elisa Fasoli" initials="EF" lastIdx="1" clrIdx="3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4" autoAdjust="0"/>
    <p:restoredTop sz="94660"/>
  </p:normalViewPr>
  <p:slideViewPr>
    <p:cSldViewPr>
      <p:cViewPr>
        <p:scale>
          <a:sx n="100" d="100"/>
          <a:sy n="100" d="100"/>
        </p:scale>
        <p:origin x="-808" y="143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4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printerSettings" Target="printerSettings/printerSettings1.bin"/><Relationship Id="rId8" Type="http://schemas.openxmlformats.org/officeDocument/2006/relationships/commentAuthors" Target="commentAuthors.xml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lena Rosini" userId="7c68c0ed64e0133e" providerId="LiveId" clId="{312661DF-D131-4D63-BA20-6872344473BD}"/>
    <pc:docChg chg="undo custSel modSld">
      <pc:chgData name="Elena Rosini" userId="7c68c0ed64e0133e" providerId="LiveId" clId="{312661DF-D131-4D63-BA20-6872344473BD}" dt="2020-03-04T14:58:57.558" v="290" actId="20577"/>
      <pc:docMkLst>
        <pc:docMk/>
      </pc:docMkLst>
      <pc:sldChg chg="modSp">
        <pc:chgData name="Elena Rosini" userId="7c68c0ed64e0133e" providerId="LiveId" clId="{312661DF-D131-4D63-BA20-6872344473BD}" dt="2020-03-04T14:55:54.863" v="284" actId="20577"/>
        <pc:sldMkLst>
          <pc:docMk/>
          <pc:sldMk cId="1781615796" sldId="258"/>
        </pc:sldMkLst>
        <pc:spChg chg="mod">
          <ac:chgData name="Elena Rosini" userId="7c68c0ed64e0133e" providerId="LiveId" clId="{312661DF-D131-4D63-BA20-6872344473BD}" dt="2020-03-04T14:55:54.863" v="284" actId="20577"/>
          <ac:spMkLst>
            <pc:docMk/>
            <pc:sldMk cId="1781615796" sldId="258"/>
            <ac:spMk id="13" creationId="{00000000-0000-0000-0000-000000000000}"/>
          </ac:spMkLst>
        </pc:spChg>
      </pc:sldChg>
      <pc:sldChg chg="modSp">
        <pc:chgData name="Elena Rosini" userId="7c68c0ed64e0133e" providerId="LiveId" clId="{312661DF-D131-4D63-BA20-6872344473BD}" dt="2020-03-04T14:56:08.695" v="286" actId="20577"/>
        <pc:sldMkLst>
          <pc:docMk/>
          <pc:sldMk cId="4213915205" sldId="269"/>
        </pc:sldMkLst>
        <pc:spChg chg="mod">
          <ac:chgData name="Elena Rosini" userId="7c68c0ed64e0133e" providerId="LiveId" clId="{312661DF-D131-4D63-BA20-6872344473BD}" dt="2020-03-04T14:56:08.695" v="286" actId="20577"/>
          <ac:spMkLst>
            <pc:docMk/>
            <pc:sldMk cId="4213915205" sldId="269"/>
            <ac:spMk id="46" creationId="{00000000-0000-0000-0000-000000000000}"/>
          </ac:spMkLst>
        </pc:spChg>
      </pc:sldChg>
      <pc:sldChg chg="modSp addCm modCm">
        <pc:chgData name="Elena Rosini" userId="7c68c0ed64e0133e" providerId="LiveId" clId="{312661DF-D131-4D63-BA20-6872344473BD}" dt="2020-03-04T14:58:57.558" v="290" actId="20577"/>
        <pc:sldMkLst>
          <pc:docMk/>
          <pc:sldMk cId="1545400203" sldId="270"/>
        </pc:sldMkLst>
        <pc:spChg chg="mod">
          <ac:chgData name="Elena Rosini" userId="7c68c0ed64e0133e" providerId="LiveId" clId="{312661DF-D131-4D63-BA20-6872344473BD}" dt="2020-03-04T14:58:57.558" v="290" actId="20577"/>
          <ac:spMkLst>
            <pc:docMk/>
            <pc:sldMk cId="1545400203" sldId="270"/>
            <ac:spMk id="3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31CF5-6D3B-4E3D-80D5-BC85F81BC1F8}" type="datetimeFigureOut">
              <a:rPr lang="it-IT" smtClean="0"/>
              <a:t>30/03/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971F3-36D6-4269-8CA9-02D10CB51694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059830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31CF5-6D3B-4E3D-80D5-BC85F81BC1F8}" type="datetimeFigureOut">
              <a:rPr lang="it-IT" smtClean="0"/>
              <a:t>30/03/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971F3-36D6-4269-8CA9-02D10CB51694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5555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31CF5-6D3B-4E3D-80D5-BC85F81BC1F8}" type="datetimeFigureOut">
              <a:rPr lang="it-IT" smtClean="0"/>
              <a:t>30/03/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971F3-36D6-4269-8CA9-02D10CB51694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023901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31CF5-6D3B-4E3D-80D5-BC85F81BC1F8}" type="datetimeFigureOut">
              <a:rPr lang="it-IT" smtClean="0"/>
              <a:t>30/03/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971F3-36D6-4269-8CA9-02D10CB51694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495160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31CF5-6D3B-4E3D-80D5-BC85F81BC1F8}" type="datetimeFigureOut">
              <a:rPr lang="it-IT" smtClean="0"/>
              <a:t>30/03/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971F3-36D6-4269-8CA9-02D10CB51694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103962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31CF5-6D3B-4E3D-80D5-BC85F81BC1F8}" type="datetimeFigureOut">
              <a:rPr lang="it-IT" smtClean="0"/>
              <a:t>30/03/2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971F3-36D6-4269-8CA9-02D10CB51694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38758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31CF5-6D3B-4E3D-80D5-BC85F81BC1F8}" type="datetimeFigureOut">
              <a:rPr lang="it-IT" smtClean="0"/>
              <a:t>30/03/22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971F3-36D6-4269-8CA9-02D10CB51694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81896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31CF5-6D3B-4E3D-80D5-BC85F81BC1F8}" type="datetimeFigureOut">
              <a:rPr lang="it-IT" smtClean="0"/>
              <a:t>30/03/22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971F3-36D6-4269-8CA9-02D10CB51694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78292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31CF5-6D3B-4E3D-80D5-BC85F81BC1F8}" type="datetimeFigureOut">
              <a:rPr lang="it-IT" smtClean="0"/>
              <a:t>30/03/22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971F3-36D6-4269-8CA9-02D10CB51694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687080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31CF5-6D3B-4E3D-80D5-BC85F81BC1F8}" type="datetimeFigureOut">
              <a:rPr lang="it-IT" smtClean="0"/>
              <a:t>30/03/2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971F3-36D6-4269-8CA9-02D10CB51694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862505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31CF5-6D3B-4E3D-80D5-BC85F81BC1F8}" type="datetimeFigureOut">
              <a:rPr lang="it-IT" smtClean="0"/>
              <a:t>30/03/2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971F3-36D6-4269-8CA9-02D10CB51694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599383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831CF5-6D3B-4E3D-80D5-BC85F81BC1F8}" type="datetimeFigureOut">
              <a:rPr lang="it-IT" smtClean="0"/>
              <a:t>30/03/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971F3-36D6-4269-8CA9-02D10CB51694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005079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4" Type="http://schemas.openxmlformats.org/officeDocument/2006/relationships/image" Target="../media/image5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4" Type="http://schemas.openxmlformats.org/officeDocument/2006/relationships/image" Target="../media/image9.tif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.tif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uppo 9"/>
          <p:cNvGrpSpPr/>
          <p:nvPr/>
        </p:nvGrpSpPr>
        <p:grpSpPr>
          <a:xfrm>
            <a:off x="2810956" y="1190584"/>
            <a:ext cx="2647300" cy="584450"/>
            <a:chOff x="866740" y="764704"/>
            <a:chExt cx="2647300" cy="584450"/>
          </a:xfrm>
        </p:grpSpPr>
        <p:grpSp>
          <p:nvGrpSpPr>
            <p:cNvPr id="12" name="Gruppo 11"/>
            <p:cNvGrpSpPr/>
            <p:nvPr/>
          </p:nvGrpSpPr>
          <p:grpSpPr>
            <a:xfrm>
              <a:off x="866740" y="1196655"/>
              <a:ext cx="2647300" cy="152499"/>
              <a:chOff x="425524" y="927620"/>
              <a:chExt cx="2880320" cy="152499"/>
            </a:xfrm>
          </p:grpSpPr>
          <p:sp>
            <p:nvSpPr>
              <p:cNvPr id="15" name="Rettangolo 14"/>
              <p:cNvSpPr/>
              <p:nvPr/>
            </p:nvSpPr>
            <p:spPr>
              <a:xfrm>
                <a:off x="425524" y="927620"/>
                <a:ext cx="288032" cy="15249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50000"/>
                  </a:lnSpc>
                  <a:spcAft>
                    <a:spcPts val="1000"/>
                  </a:spcAft>
                </a:pPr>
                <a:r>
                  <a:rPr lang="it-IT" sz="1200">
                    <a:effectLst/>
                    <a:latin typeface="Times New Roman"/>
                    <a:ea typeface="Times New Roman"/>
                    <a:cs typeface="Times New Roman"/>
                  </a:rPr>
                  <a:t> </a:t>
                </a:r>
                <a:endParaRPr lang="it-IT" sz="1200">
                  <a:effectLst/>
                  <a:latin typeface="Times New Roman"/>
                  <a:ea typeface="Calibri"/>
                  <a:cs typeface="Times New Roman"/>
                </a:endParaRPr>
              </a:p>
            </p:txBody>
          </p:sp>
          <p:sp>
            <p:nvSpPr>
              <p:cNvPr id="16" name="Rettangolo 15"/>
              <p:cNvSpPr/>
              <p:nvPr/>
            </p:nvSpPr>
            <p:spPr>
              <a:xfrm>
                <a:off x="3017812" y="927620"/>
                <a:ext cx="288032" cy="15249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50000"/>
                  </a:lnSpc>
                  <a:spcAft>
                    <a:spcPts val="1000"/>
                  </a:spcAft>
                </a:pPr>
                <a:r>
                  <a:rPr lang="it-IT" sz="1200">
                    <a:effectLst/>
                    <a:latin typeface="Times New Roman"/>
                    <a:ea typeface="Times New Roman"/>
                    <a:cs typeface="Times New Roman"/>
                  </a:rPr>
                  <a:t> </a:t>
                </a:r>
                <a:endParaRPr lang="it-IT" sz="1200">
                  <a:effectLst/>
                  <a:latin typeface="Times New Roman"/>
                  <a:ea typeface="Calibri"/>
                  <a:cs typeface="Times New Roman"/>
                </a:endParaRPr>
              </a:p>
            </p:txBody>
          </p:sp>
        </p:grpSp>
        <p:sp>
          <p:nvSpPr>
            <p:cNvPr id="13" name="Rettangolo 12"/>
            <p:cNvSpPr/>
            <p:nvPr/>
          </p:nvSpPr>
          <p:spPr>
            <a:xfrm>
              <a:off x="2123728" y="764704"/>
              <a:ext cx="144016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2" name="CasellaDiTesto 1"/>
          <p:cNvSpPr txBox="1"/>
          <p:nvPr/>
        </p:nvSpPr>
        <p:spPr>
          <a:xfrm>
            <a:off x="138772" y="6021288"/>
            <a:ext cx="85689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1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hematic representation of MWCNTs functionalization.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ide-wall MWCNTs-COOH PEGylation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ide-wall MWCNTs-COOH functionalization with PLGA. For the functionalization reported in A, MPEGA 5K is methoxypolyethylene glycol amine with a molecular weight of 5 KDa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Gruppo 20"/>
          <p:cNvGrpSpPr/>
          <p:nvPr/>
        </p:nvGrpSpPr>
        <p:grpSpPr>
          <a:xfrm>
            <a:off x="1619672" y="188640"/>
            <a:ext cx="6192688" cy="5256584"/>
            <a:chOff x="2150663" y="1657500"/>
            <a:chExt cx="4755051" cy="4099600"/>
          </a:xfrm>
        </p:grpSpPr>
        <p:grpSp>
          <p:nvGrpSpPr>
            <p:cNvPr id="20" name="Gruppo 19"/>
            <p:cNvGrpSpPr/>
            <p:nvPr/>
          </p:nvGrpSpPr>
          <p:grpSpPr>
            <a:xfrm>
              <a:off x="2225194" y="1657500"/>
              <a:ext cx="4680520" cy="1196013"/>
              <a:chOff x="2225194" y="1657500"/>
              <a:chExt cx="4680520" cy="1196013"/>
            </a:xfrm>
          </p:grpSpPr>
          <p:pic>
            <p:nvPicPr>
              <p:cNvPr id="8" name="Immagine 7"/>
              <p:cNvPicPr/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225194" y="1895776"/>
                <a:ext cx="4680520" cy="957737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9" name="CasellaDiTesto 8"/>
              <p:cNvSpPr txBox="1"/>
              <p:nvPr/>
            </p:nvSpPr>
            <p:spPr>
              <a:xfrm>
                <a:off x="4336500" y="1657500"/>
                <a:ext cx="226726" cy="2160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</p:grpSp>
        <p:grpSp>
          <p:nvGrpSpPr>
            <p:cNvPr id="5" name="Gruppo 4"/>
            <p:cNvGrpSpPr/>
            <p:nvPr/>
          </p:nvGrpSpPr>
          <p:grpSpPr>
            <a:xfrm>
              <a:off x="2150663" y="3662881"/>
              <a:ext cx="4752528" cy="2094219"/>
              <a:chOff x="206447" y="3237000"/>
              <a:chExt cx="4752528" cy="2094219"/>
            </a:xfrm>
          </p:grpSpPr>
          <p:pic>
            <p:nvPicPr>
              <p:cNvPr id="6" name="Immagine 5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06447" y="3670592"/>
                <a:ext cx="4752528" cy="1660627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7" name="CasellaDiTesto 6"/>
              <p:cNvSpPr txBox="1"/>
              <p:nvPr/>
            </p:nvSpPr>
            <p:spPr>
              <a:xfrm>
                <a:off x="2407429" y="3237000"/>
                <a:ext cx="226726" cy="2160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2335295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uppo 11"/>
          <p:cNvGrpSpPr/>
          <p:nvPr/>
        </p:nvGrpSpPr>
        <p:grpSpPr>
          <a:xfrm>
            <a:off x="107504" y="332656"/>
            <a:ext cx="8810085" cy="5567024"/>
            <a:chOff x="107504" y="836712"/>
            <a:chExt cx="8810085" cy="5567024"/>
          </a:xfrm>
        </p:grpSpPr>
        <p:sp>
          <p:nvSpPr>
            <p:cNvPr id="7" name="CasellaDiTesto 6"/>
            <p:cNvSpPr txBox="1"/>
            <p:nvPr/>
          </p:nvSpPr>
          <p:spPr>
            <a:xfrm>
              <a:off x="417979" y="3298173"/>
              <a:ext cx="2952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8" name="CasellaDiTesto 7"/>
            <p:cNvSpPr txBox="1"/>
            <p:nvPr/>
          </p:nvSpPr>
          <p:spPr>
            <a:xfrm>
              <a:off x="8225288" y="3313562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9" name="CasellaDiTesto 8"/>
            <p:cNvSpPr txBox="1"/>
            <p:nvPr/>
          </p:nvSpPr>
          <p:spPr>
            <a:xfrm>
              <a:off x="4226617" y="6126737"/>
              <a:ext cx="8284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pic>
          <p:nvPicPr>
            <p:cNvPr id="5" name="Immagine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7504" y="836712"/>
              <a:ext cx="4389308" cy="237626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" name="Immagine 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640828" y="836712"/>
              <a:ext cx="4276761" cy="237626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" name="Immagine 10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204811" y="3428978"/>
              <a:ext cx="4609403" cy="261256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13" name="CasellaDiTesto 12"/>
          <p:cNvSpPr txBox="1"/>
          <p:nvPr/>
        </p:nvSpPr>
        <p:spPr>
          <a:xfrm>
            <a:off x="847230" y="6165304"/>
            <a:ext cx="73245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2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GA analysis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25% PEG-MWCNTs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12% PEG-MWCNTs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10% PLGA-MWCNTs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16157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3648" y="836712"/>
            <a:ext cx="5455188" cy="4139299"/>
          </a:xfrm>
          <a:prstGeom prst="rect">
            <a:avLst/>
          </a:prstGeom>
        </p:spPr>
      </p:pic>
      <p:sp>
        <p:nvSpPr>
          <p:cNvPr id="3" name="Rettangolo 2"/>
          <p:cNvSpPr/>
          <p:nvPr/>
        </p:nvSpPr>
        <p:spPr>
          <a:xfrm>
            <a:off x="611560" y="5517232"/>
            <a:ext cx="777686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. S3 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pectral analysis of the secondary structure of native and on MWCNTs-loaded DAAO. Native DAAO (black line), 10% PLGA-MWCNTs-DAAO (red line), 12% PEG-MWCNTs-DAAO (green line) and 25% PEG-MWCNTs-DAAO (blue line) enzymes. The far-UV spectra were recorded at 15 °C, in 50 mM sodium pyrophosphate, pH 7.4</a:t>
            </a:r>
            <a:endParaRPr lang="it-IT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26523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CasellaDiTesto 45"/>
          <p:cNvSpPr txBox="1"/>
          <p:nvPr/>
        </p:nvSpPr>
        <p:spPr>
          <a:xfrm>
            <a:off x="-18736" y="5797713"/>
            <a:ext cx="919924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4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DS-PAGE analysis of protein corona formed </a:t>
            </a:r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n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EG-MWCNTs and PLGA-MWCNTs. Gels </a:t>
            </a:r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ow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protein profiles of  samples eluted from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2% PEGylated (10 µL)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% PEGylated (6 µL) and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% PLGA (10 µ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nctionalized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anotube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l f-MWCNTs </a:t>
            </a:r>
            <a:r>
              <a:rPr lang="en-US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luates</a:t>
            </a:r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ere treated with the reducing agent 2-mercaptoethanol (DE</a:t>
            </a: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without 2-mercaptoethanol (NE)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ach gel, f-MWCNTs was loaded on the left of the marker, while f-MWCNTs-DAAO was loaded on the right side. After the incubation with </a:t>
            </a:r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man </a:t>
            </a:r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asm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th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lution </a:t>
            </a:r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 interacting protein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as performed in TrisHCl pH 7.4 at 37 °C, both in native and denaturant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nditions.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Gruppo 7"/>
          <p:cNvGrpSpPr/>
          <p:nvPr/>
        </p:nvGrpSpPr>
        <p:grpSpPr>
          <a:xfrm>
            <a:off x="1481841" y="116632"/>
            <a:ext cx="5701088" cy="5378120"/>
            <a:chOff x="1481841" y="337521"/>
            <a:chExt cx="5701088" cy="5378120"/>
          </a:xfrm>
        </p:grpSpPr>
        <p:pic>
          <p:nvPicPr>
            <p:cNvPr id="14" name="Immagine 1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7286"/>
            <a:stretch/>
          </p:blipFill>
          <p:spPr>
            <a:xfrm>
              <a:off x="1527449" y="1194793"/>
              <a:ext cx="2495841" cy="1585068"/>
            </a:xfrm>
            <a:prstGeom prst="rect">
              <a:avLst/>
            </a:prstGeom>
          </p:spPr>
        </p:pic>
        <p:sp>
          <p:nvSpPr>
            <p:cNvPr id="9" name="CasellaDiTesto 8"/>
            <p:cNvSpPr txBox="1"/>
            <p:nvPr/>
          </p:nvSpPr>
          <p:spPr>
            <a:xfrm rot="18896426">
              <a:off x="1587203" y="819402"/>
              <a:ext cx="3984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E</a:t>
              </a:r>
              <a:endParaRPr lang="it-IT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CasellaDiTesto 10"/>
            <p:cNvSpPr txBox="1"/>
            <p:nvPr/>
          </p:nvSpPr>
          <p:spPr>
            <a:xfrm rot="18896426">
              <a:off x="2509765" y="645986"/>
              <a:ext cx="7830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r</a:t>
              </a:r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it-IT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it-I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CasellaDiTesto 11"/>
            <p:cNvSpPr txBox="1"/>
            <p:nvPr/>
          </p:nvSpPr>
          <p:spPr>
            <a:xfrm rot="18896426">
              <a:off x="3059474" y="649920"/>
              <a:ext cx="8773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DAAO </a:t>
              </a:r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E</a:t>
              </a:r>
              <a:endParaRPr lang="it-I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CasellaDiTesto 12"/>
            <p:cNvSpPr txBox="1"/>
            <p:nvPr/>
          </p:nvSpPr>
          <p:spPr>
            <a:xfrm rot="18896426">
              <a:off x="3567556" y="637678"/>
              <a:ext cx="8773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DAAO </a:t>
              </a:r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E</a:t>
              </a:r>
              <a:endParaRPr lang="it-I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CasellaDiTesto 4"/>
            <p:cNvSpPr txBox="1"/>
            <p:nvPr/>
          </p:nvSpPr>
          <p:spPr>
            <a:xfrm>
              <a:off x="2783496" y="1213187"/>
              <a:ext cx="33855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</a:p>
            <a:p>
              <a:r>
                <a:rPr lang="en-GB" sz="7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  <a:p>
              <a:r>
                <a:rPr lang="en-GB" sz="7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r>
                <a:rPr lang="en-GB" sz="7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6" name="CasellaDiTesto 5"/>
            <p:cNvSpPr txBox="1"/>
            <p:nvPr/>
          </p:nvSpPr>
          <p:spPr>
            <a:xfrm>
              <a:off x="2780257" y="1693064"/>
              <a:ext cx="296214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  <a:p>
              <a:endParaRPr lang="en-GB" sz="7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GB" sz="7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CasellaDiTesto 6"/>
            <p:cNvSpPr txBox="1"/>
            <p:nvPr/>
          </p:nvSpPr>
          <p:spPr>
            <a:xfrm>
              <a:off x="2783496" y="1849137"/>
              <a:ext cx="296214" cy="9541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  <a:p>
              <a:endParaRPr lang="en-GB" sz="7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GB" sz="7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GB" sz="7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endParaRPr lang="en-GB" sz="7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GB" sz="7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endParaRPr lang="en-GB" sz="7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GB" sz="7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2" name="Immagine 2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498246" y="1216588"/>
              <a:ext cx="2613009" cy="1563273"/>
            </a:xfrm>
            <a:prstGeom prst="rect">
              <a:avLst/>
            </a:prstGeom>
          </p:spPr>
        </p:pic>
        <p:sp>
          <p:nvSpPr>
            <p:cNvPr id="26" name="CasellaDiTesto 25"/>
            <p:cNvSpPr txBox="1"/>
            <p:nvPr/>
          </p:nvSpPr>
          <p:spPr>
            <a:xfrm rot="18896426">
              <a:off x="5534101" y="688161"/>
              <a:ext cx="7830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r</a:t>
              </a:r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it-IT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it-I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CasellaDiTesto 18"/>
            <p:cNvSpPr txBox="1"/>
            <p:nvPr/>
          </p:nvSpPr>
          <p:spPr>
            <a:xfrm>
              <a:off x="5851492" y="1276976"/>
              <a:ext cx="33855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</a:p>
            <a:p>
              <a:r>
                <a:rPr lang="en-GB" sz="7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  <a:p>
              <a:r>
                <a:rPr lang="en-GB" sz="7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r>
                <a:rPr lang="en-GB" sz="7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20" name="CasellaDiTesto 19"/>
            <p:cNvSpPr txBox="1"/>
            <p:nvPr/>
          </p:nvSpPr>
          <p:spPr>
            <a:xfrm>
              <a:off x="5848258" y="1741213"/>
              <a:ext cx="295741" cy="4154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  <a:p>
              <a:endParaRPr lang="en-GB" sz="7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GB" sz="7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CasellaDiTesto 20"/>
            <p:cNvSpPr txBox="1"/>
            <p:nvPr/>
          </p:nvSpPr>
          <p:spPr>
            <a:xfrm>
              <a:off x="5851492" y="1892200"/>
              <a:ext cx="295741" cy="9541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  <a:p>
              <a:endParaRPr lang="en-GB" sz="7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GB" sz="7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GB" sz="7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endParaRPr lang="en-GB" sz="7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GB" sz="7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endParaRPr lang="en-GB" sz="7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GB" sz="7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5" name="Immagine 34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95664" y="3864302"/>
              <a:ext cx="2906994" cy="1813850"/>
            </a:xfrm>
            <a:prstGeom prst="rect">
              <a:avLst/>
            </a:prstGeom>
          </p:spPr>
        </p:pic>
        <p:sp>
          <p:nvSpPr>
            <p:cNvPr id="32" name="CasellaDiTesto 31"/>
            <p:cNvSpPr txBox="1"/>
            <p:nvPr/>
          </p:nvSpPr>
          <p:spPr>
            <a:xfrm>
              <a:off x="4359630" y="3887445"/>
              <a:ext cx="33855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</a:p>
            <a:p>
              <a:r>
                <a:rPr lang="en-GB" sz="7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  <a:p>
              <a:r>
                <a:rPr lang="en-GB" sz="7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r>
                <a:rPr lang="en-GB" sz="7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33" name="CasellaDiTesto 32"/>
            <p:cNvSpPr txBox="1"/>
            <p:nvPr/>
          </p:nvSpPr>
          <p:spPr>
            <a:xfrm>
              <a:off x="4356171" y="4389967"/>
              <a:ext cx="316331" cy="4167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  <a:p>
              <a:endParaRPr lang="en-GB" sz="7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GB" sz="7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CasellaDiTesto 33"/>
            <p:cNvSpPr txBox="1"/>
            <p:nvPr/>
          </p:nvSpPr>
          <p:spPr>
            <a:xfrm>
              <a:off x="4359630" y="4553405"/>
              <a:ext cx="316331" cy="956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  <a:p>
              <a:endParaRPr lang="en-GB" sz="7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GB" sz="7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GB" sz="7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endParaRPr lang="en-GB" sz="7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GB" sz="7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endParaRPr lang="en-GB" sz="7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GB" sz="700" b="1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CasellaDiTesto 41"/>
            <p:cNvSpPr txBox="1"/>
            <p:nvPr/>
          </p:nvSpPr>
          <p:spPr>
            <a:xfrm>
              <a:off x="1481841" y="2832090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43" name="CasellaDiTesto 42"/>
            <p:cNvSpPr txBox="1"/>
            <p:nvPr/>
          </p:nvSpPr>
          <p:spPr>
            <a:xfrm>
              <a:off x="6779527" y="2832090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44" name="CasellaDiTesto 43"/>
            <p:cNvSpPr txBox="1"/>
            <p:nvPr/>
          </p:nvSpPr>
          <p:spPr>
            <a:xfrm>
              <a:off x="5680568" y="5438642"/>
              <a:ext cx="6997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47" name="CasellaDiTesto 46"/>
            <p:cNvSpPr txBox="1"/>
            <p:nvPr/>
          </p:nvSpPr>
          <p:spPr>
            <a:xfrm rot="18896426">
              <a:off x="2045788" y="793046"/>
              <a:ext cx="3984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it-I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CasellaDiTesto 47"/>
            <p:cNvSpPr txBox="1"/>
            <p:nvPr/>
          </p:nvSpPr>
          <p:spPr>
            <a:xfrm rot="18896426">
              <a:off x="6097690" y="649920"/>
              <a:ext cx="8773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DAAO </a:t>
              </a:r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E</a:t>
              </a:r>
              <a:endParaRPr lang="it-I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CasellaDiTesto 48"/>
            <p:cNvSpPr txBox="1"/>
            <p:nvPr/>
          </p:nvSpPr>
          <p:spPr>
            <a:xfrm rot="18896426">
              <a:off x="6605773" y="637678"/>
              <a:ext cx="8773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DAAO </a:t>
              </a:r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E</a:t>
              </a:r>
              <a:endParaRPr lang="it-I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CasellaDiTesto 49"/>
            <p:cNvSpPr txBox="1"/>
            <p:nvPr/>
          </p:nvSpPr>
          <p:spPr>
            <a:xfrm rot="18896426">
              <a:off x="4539531" y="819402"/>
              <a:ext cx="3984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E</a:t>
              </a:r>
              <a:endParaRPr lang="it-IT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CasellaDiTesto 50"/>
            <p:cNvSpPr txBox="1"/>
            <p:nvPr/>
          </p:nvSpPr>
          <p:spPr>
            <a:xfrm rot="18896426">
              <a:off x="5070124" y="793046"/>
              <a:ext cx="3984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it-I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CasellaDiTesto 51"/>
            <p:cNvSpPr txBox="1"/>
            <p:nvPr/>
          </p:nvSpPr>
          <p:spPr>
            <a:xfrm rot="18896426">
              <a:off x="2955355" y="3483699"/>
              <a:ext cx="3984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E</a:t>
              </a:r>
              <a:endParaRPr lang="it-IT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CasellaDiTesto 52"/>
            <p:cNvSpPr txBox="1"/>
            <p:nvPr/>
          </p:nvSpPr>
          <p:spPr>
            <a:xfrm rot="18896426">
              <a:off x="4093941" y="3382290"/>
              <a:ext cx="7830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r</a:t>
              </a:r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it-IT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it-I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CasellaDiTesto 53"/>
            <p:cNvSpPr txBox="1"/>
            <p:nvPr/>
          </p:nvSpPr>
          <p:spPr>
            <a:xfrm rot="18896426">
              <a:off x="4729539" y="3314217"/>
              <a:ext cx="8773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DAAO </a:t>
              </a:r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E</a:t>
              </a:r>
              <a:endParaRPr lang="it-I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CasellaDiTesto 54"/>
            <p:cNvSpPr txBox="1"/>
            <p:nvPr/>
          </p:nvSpPr>
          <p:spPr>
            <a:xfrm rot="18896426">
              <a:off x="5309629" y="3301975"/>
              <a:ext cx="8773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DAAO </a:t>
              </a:r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E</a:t>
              </a:r>
              <a:endParaRPr lang="it-I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CasellaDiTesto 55"/>
            <p:cNvSpPr txBox="1"/>
            <p:nvPr/>
          </p:nvSpPr>
          <p:spPr>
            <a:xfrm rot="18896426">
              <a:off x="3531419" y="3457343"/>
              <a:ext cx="3984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it-I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it-I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139152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/>
          <p:cNvSpPr txBox="1"/>
          <p:nvPr/>
        </p:nvSpPr>
        <p:spPr>
          <a:xfrm>
            <a:off x="755576" y="5229200"/>
            <a:ext cx="7471873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5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Dependence on D-Ala concentration of cytotoxicity induced by free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AAO </a:t>
            </a:r>
            <a:r>
              <a:rPr lang="en-GB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lack bars)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12% PEG-MWCNTs-DAAO </a:t>
            </a:r>
            <a:r>
              <a:rPr lang="en-GB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rk grey bars)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10% PLGA-MWCNTs-DAAO </a:t>
            </a:r>
            <a:r>
              <a:rPr lang="en-GB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light grey bars)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n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U87 cells. Toxicity was quantified as the fraction of surviving cells relative to the untreated cells as control (i.e., the cells incubated without DAAO or D-Ala) taken as 100% of survival. </a:t>
            </a:r>
            <a:r>
              <a:rPr lang="en-GB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values are reported as mean ± standard deviation (n = 5). The results were evaluated by statistical analysis using two‐way ANOVA followed by a Tukey's multiple comparison test</a:t>
            </a:r>
            <a:r>
              <a:rPr lang="en-GB" sz="12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GB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&lt; 0.001.</a:t>
            </a:r>
          </a:p>
          <a:p>
            <a:pPr algn="ctr"/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Immagin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7664" y="548680"/>
            <a:ext cx="5346730" cy="43651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540020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2</TotalTime>
  <Words>490</Words>
  <Application>Microsoft Macintosh PowerPoint</Application>
  <PresentationFormat>Presentazione su schermo (4:3)</PresentationFormat>
  <Paragraphs>63</Paragraphs>
  <Slides>5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6" baseType="lpstr">
      <vt:lpstr>Tema di Office</vt:lpstr>
      <vt:lpstr>Presentazione di PowerPoint</vt:lpstr>
      <vt:lpstr>Presentazione di PowerPoint</vt:lpstr>
      <vt:lpstr>Presentazione di PowerPoint</vt:lpstr>
      <vt:lpstr>Presentazione di PowerPoint</vt:lpstr>
      <vt:lpstr>Presentazione di PowerPoint</vt:lpstr>
    </vt:vector>
  </TitlesOfParts>
  <Company>Dipartimento CMIC - Politecnico di Milan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ta Boreggio</dc:creator>
  <cp:lastModifiedBy>Elisa Fasoli</cp:lastModifiedBy>
  <cp:revision>93</cp:revision>
  <cp:lastPrinted>2020-03-02T13:02:16Z</cp:lastPrinted>
  <dcterms:created xsi:type="dcterms:W3CDTF">2019-10-18T08:58:51Z</dcterms:created>
  <dcterms:modified xsi:type="dcterms:W3CDTF">2022-03-30T08:03:11Z</dcterms:modified>
</cp:coreProperties>
</file>